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jpeg" ContentType="image/jpeg"/>
  <Override PartName="/ppt/media/image14.jpeg" ContentType="image/jpeg"/>
  <Override PartName="/ppt/media/image2.png" ContentType="image/png"/>
  <Override PartName="/ppt/media/image1.png" ContentType="image/png"/>
  <Override PartName="/ppt/media/image3.png" ContentType="image/png"/>
  <Override PartName="/ppt/media/image4.png" ContentType="image/png"/>
  <Override PartName="/ppt/media/image13.jpeg" ContentType="image/jpeg"/>
  <Override PartName="/ppt/media/image5.jpeg" ContentType="image/jpeg"/>
  <Override PartName="/ppt/media/image8.jpeg" ContentType="image/jpeg"/>
  <Override PartName="/ppt/media/image10.jpeg" ContentType="image/jpeg"/>
  <Override PartName="/ppt/media/image6.jpeg" ContentType="image/jpeg"/>
  <Override PartName="/ppt/media/image9.jpeg" ContentType="image/jpeg"/>
  <Override PartName="/ppt/media/image11.jpeg" ContentType="image/jpeg"/>
  <Override PartName="/ppt/media/image7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3201B-6226-4291-8548-2F0D574745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7FB1DD-5621-4D58-8FD4-57AF36577E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C3FA2-36AC-4BC0-8C1B-9E47DF8458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A0BE3-60D0-4CC2-8CF0-ADD166DCEB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EC3DC-3F28-4F9A-AF8E-0CAC9603EE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3352E-FD58-4477-BF03-7925958E6D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D9762-78B7-4E6C-BF67-AE7C388CFD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6C2D0-F81A-4B0D-BB4A-CFA8636D68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2A873-4416-4A53-A12A-9DBF470705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5D082-DF5F-4107-A7E8-1F3AEB6F7E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E812D-DC5C-40A4-ADFE-1C5DA28395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3624D-808F-410A-A57C-EAD224D97D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A0558D-CC89-44E7-A8F3-80776F62B3F3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image" Target="../media/image9.jpeg"/><Relationship Id="rId6" Type="http://schemas.openxmlformats.org/officeDocument/2006/relationships/image" Target="../media/image10.jpe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jpeg"/><Relationship Id="rId3" Type="http://schemas.openxmlformats.org/officeDocument/2006/relationships/image" Target="../media/image13.jpeg"/><Relationship Id="rId4" Type="http://schemas.openxmlformats.org/officeDocument/2006/relationships/image" Target="../media/image1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P35 sample NeuN, MBP, GFAP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8"/>
          <p:cNvSpPr/>
          <p:nvPr/>
        </p:nvSpPr>
        <p:spPr>
          <a:xfrm>
            <a:off x="0" y="0"/>
            <a:ext cx="550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NeuN (</a:t>
            </a:r>
            <a:r>
              <a:rPr b="0" lang="en-US" sz="18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3NMDA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vs 3Saline)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142920" y="1305000"/>
            <a:ext cx="335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3  F4   F1  F4  </a:t>
            </a: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1  F2  F3   F5</a:t>
            </a: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TextBox 16"/>
          <p:cNvSpPr/>
          <p:nvPr/>
        </p:nvSpPr>
        <p:spPr>
          <a:xfrm>
            <a:off x="3500280" y="166860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Neu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TextBox 17"/>
          <p:cNvSpPr/>
          <p:nvPr/>
        </p:nvSpPr>
        <p:spPr>
          <a:xfrm>
            <a:off x="3500280" y="232416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TextBox 5"/>
          <p:cNvSpPr/>
          <p:nvPr/>
        </p:nvSpPr>
        <p:spPr>
          <a:xfrm>
            <a:off x="142920" y="1050840"/>
            <a:ext cx="3357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33  #33 #32 #32  </a:t>
            </a:r>
            <a:r>
              <a:rPr b="1" lang="en-US" sz="14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#33 #33 #33 #33  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0" y="701640"/>
            <a:ext cx="264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1set</a:t>
            </a:r>
            <a:r>
              <a:rPr b="0" lang="ko-KR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8" name="Picture 5" descr="C:\Documents and Settings\MYHOME\My Documents\스캔\YMS\20150709Actin 7차, 9차 10%.tif"/>
          <p:cNvPicPr/>
          <p:nvPr/>
        </p:nvPicPr>
        <p:blipFill>
          <a:blip r:embed="rId1"/>
          <a:srcRect l="8255" t="22137" r="57496" b="72427"/>
          <a:stretch/>
        </p:blipFill>
        <p:spPr>
          <a:xfrm>
            <a:off x="0" y="2071800"/>
            <a:ext cx="3600360" cy="8078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C:\Documents and Settings\MYHOME\My Documents\스캔\YMS\20150707NeuN 7차, 9차 10%.tif"/>
          <p:cNvPicPr/>
          <p:nvPr/>
        </p:nvPicPr>
        <p:blipFill>
          <a:blip r:embed="rId2"/>
          <a:srcRect l="10388" t="47454" r="55606" b="49205"/>
          <a:stretch/>
        </p:blipFill>
        <p:spPr>
          <a:xfrm>
            <a:off x="0" y="1643040"/>
            <a:ext cx="3600360" cy="500040"/>
          </a:xfrm>
          <a:prstGeom prst="rect">
            <a:avLst/>
          </a:prstGeom>
          <a:ln w="0">
            <a:noFill/>
          </a:ln>
        </p:spPr>
      </p:pic>
      <p:sp>
        <p:nvSpPr>
          <p:cNvPr id="50" name="TextBox 5"/>
          <p:cNvSpPr/>
          <p:nvPr/>
        </p:nvSpPr>
        <p:spPr>
          <a:xfrm>
            <a:off x="214200" y="4173480"/>
            <a:ext cx="3214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1 M3 F3  F6  </a:t>
            </a: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2  M4 F2  F4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TextBox 16"/>
          <p:cNvSpPr/>
          <p:nvPr/>
        </p:nvSpPr>
        <p:spPr>
          <a:xfrm>
            <a:off x="3500280" y="459756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Neu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TextBox 17"/>
          <p:cNvSpPr/>
          <p:nvPr/>
        </p:nvSpPr>
        <p:spPr>
          <a:xfrm>
            <a:off x="3500280" y="521496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3" name="TextBox 5"/>
          <p:cNvSpPr/>
          <p:nvPr/>
        </p:nvSpPr>
        <p:spPr>
          <a:xfrm>
            <a:off x="142920" y="3936960"/>
            <a:ext cx="32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44 #44 #44 #44  </a:t>
            </a:r>
            <a:r>
              <a:rPr b="1" lang="en-US" sz="14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#44 #44 #44 #4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TextBox 8"/>
          <p:cNvSpPr/>
          <p:nvPr/>
        </p:nvSpPr>
        <p:spPr>
          <a:xfrm>
            <a:off x="0" y="3571920"/>
            <a:ext cx="264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3set 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5" name="Picture 4" descr="C:\Documents and Settings\MYHOME\My Documents\스캔\YMS\20150707NeuN 7차, 9차 10%.tif"/>
          <p:cNvPicPr/>
          <p:nvPr/>
        </p:nvPicPr>
        <p:blipFill>
          <a:blip r:embed="rId3"/>
          <a:srcRect l="56677" t="48124" r="8374" b="48538"/>
          <a:stretch/>
        </p:blipFill>
        <p:spPr>
          <a:xfrm>
            <a:off x="0" y="4551480"/>
            <a:ext cx="3571920" cy="4824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5" descr="C:\Documents and Settings\MYHOME\My Documents\스캔\YMS\20150709Actin 7차, 9차 10%.tif"/>
          <p:cNvPicPr/>
          <p:nvPr/>
        </p:nvPicPr>
        <p:blipFill>
          <a:blip r:embed="rId4"/>
          <a:srcRect l="57624" t="80874" r="7432" b="14452"/>
          <a:stretch/>
        </p:blipFill>
        <p:spPr>
          <a:xfrm>
            <a:off x="0" y="4979880"/>
            <a:ext cx="3571920" cy="676440"/>
          </a:xfrm>
          <a:prstGeom prst="rect">
            <a:avLst/>
          </a:prstGeom>
          <a:ln w="0">
            <a:noFill/>
          </a:ln>
        </p:spPr>
      </p:pic>
      <p:sp>
        <p:nvSpPr>
          <p:cNvPr id="57" name="TextBox 5"/>
          <p:cNvSpPr/>
          <p:nvPr/>
        </p:nvSpPr>
        <p:spPr>
          <a:xfrm>
            <a:off x="5218200" y="1247760"/>
            <a:ext cx="335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3  M6  F1 </a:t>
            </a: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M4  M5 M7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TextBox 16"/>
          <p:cNvSpPr/>
          <p:nvPr/>
        </p:nvSpPr>
        <p:spPr>
          <a:xfrm>
            <a:off x="8075520" y="173520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Neu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TextBox 17"/>
          <p:cNvSpPr/>
          <p:nvPr/>
        </p:nvSpPr>
        <p:spPr>
          <a:xfrm>
            <a:off x="8075520" y="239076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TextBox 5"/>
          <p:cNvSpPr/>
          <p:nvPr/>
        </p:nvSpPr>
        <p:spPr>
          <a:xfrm>
            <a:off x="5218200" y="1011240"/>
            <a:ext cx="32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42  #42 #42 </a:t>
            </a:r>
            <a:r>
              <a:rPr b="1" lang="en-US" sz="14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#42  #42 #42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1" name="TextBox 8"/>
          <p:cNvSpPr/>
          <p:nvPr/>
        </p:nvSpPr>
        <p:spPr>
          <a:xfrm>
            <a:off x="5003640" y="712800"/>
            <a:ext cx="2643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2set</a:t>
            </a:r>
            <a:r>
              <a:rPr b="0" lang="ko-KR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2" name="Picture 6" descr="C:\Documents and Settings\MYHOME\My Documents\스캔\YMS\20150709NeuN 8차+#44(2) 10%.tif"/>
          <p:cNvPicPr/>
          <p:nvPr/>
        </p:nvPicPr>
        <p:blipFill>
          <a:blip r:embed="rId5"/>
          <a:srcRect l="52478" t="20713" r="19186" b="75562"/>
          <a:stretch/>
        </p:blipFill>
        <p:spPr>
          <a:xfrm>
            <a:off x="5003640" y="1582560"/>
            <a:ext cx="3071880" cy="57168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7" descr="C:\Documents and Settings\MYHOME\My Documents\스캔\YMS\20150713Actin 8차+#44(2) 10%.tif"/>
          <p:cNvPicPr/>
          <p:nvPr/>
        </p:nvPicPr>
        <p:blipFill>
          <a:blip r:embed="rId6"/>
          <a:srcRect l="48303" t="58878" r="23366" b="36448"/>
          <a:stretch/>
        </p:blipFill>
        <p:spPr>
          <a:xfrm>
            <a:off x="5003640" y="2154240"/>
            <a:ext cx="3000600" cy="700200"/>
          </a:xfrm>
          <a:prstGeom prst="rect">
            <a:avLst/>
          </a:prstGeom>
          <a:ln w="0">
            <a:noFill/>
          </a:ln>
        </p:spPr>
      </p:pic>
      <p:sp>
        <p:nvSpPr>
          <p:cNvPr id="64" name="TextBox 5"/>
          <p:cNvSpPr/>
          <p:nvPr/>
        </p:nvSpPr>
        <p:spPr>
          <a:xfrm>
            <a:off x="5218200" y="4094280"/>
            <a:ext cx="335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1  F7  </a:t>
            </a: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3 F8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TextBox 16"/>
          <p:cNvSpPr/>
          <p:nvPr/>
        </p:nvSpPr>
        <p:spPr>
          <a:xfrm>
            <a:off x="7075440" y="458136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Neu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TextBox 17"/>
          <p:cNvSpPr/>
          <p:nvPr/>
        </p:nvSpPr>
        <p:spPr>
          <a:xfrm>
            <a:off x="7075440" y="523728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7" name="TextBox 5"/>
          <p:cNvSpPr/>
          <p:nvPr/>
        </p:nvSpPr>
        <p:spPr>
          <a:xfrm>
            <a:off x="5218200" y="3857760"/>
            <a:ext cx="32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32 #44  </a:t>
            </a:r>
            <a:r>
              <a:rPr b="1" lang="en-US" sz="14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#32 #4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TextBox 8"/>
          <p:cNvSpPr/>
          <p:nvPr/>
        </p:nvSpPr>
        <p:spPr>
          <a:xfrm>
            <a:off x="5003640" y="3559320"/>
            <a:ext cx="2643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2set</a:t>
            </a:r>
            <a:r>
              <a:rPr b="0" lang="ko-KR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9" name="Picture 6" descr="C:\Documents and Settings\MYHOME\My Documents\스캔\YMS\20150709NeuN 8차+#44(2) 10%.tif"/>
          <p:cNvPicPr/>
          <p:nvPr/>
        </p:nvPicPr>
        <p:blipFill>
          <a:blip r:embed="rId7"/>
          <a:srcRect l="22252" t="46767" r="58577" b="49498"/>
          <a:stretch/>
        </p:blipFill>
        <p:spPr>
          <a:xfrm>
            <a:off x="5003640" y="4429080"/>
            <a:ext cx="2071800" cy="57168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7" descr="C:\Documents and Settings\MYHOME\My Documents\스캔\YMS\20150713Actin 8차+#44(2) 10%.tif"/>
          <p:cNvPicPr/>
          <p:nvPr/>
        </p:nvPicPr>
        <p:blipFill>
          <a:blip r:embed="rId8"/>
          <a:srcRect l="19962" t="21447" r="60205" b="73878"/>
          <a:stretch/>
        </p:blipFill>
        <p:spPr>
          <a:xfrm>
            <a:off x="5003640" y="5000760"/>
            <a:ext cx="2071800" cy="69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icture 3" descr="C:\Documents and Settings\MYHOME\My Documents\WB\8차 WB정리 (20140715- )\20140717Actin(15%,10s).jpg"/>
          <p:cNvPicPr/>
          <p:nvPr/>
        </p:nvPicPr>
        <p:blipFill>
          <a:blip r:embed="rId1"/>
          <a:stretch/>
        </p:blipFill>
        <p:spPr>
          <a:xfrm>
            <a:off x="5003640" y="2498760"/>
            <a:ext cx="3511800" cy="1001520"/>
          </a:xfrm>
          <a:prstGeom prst="rect">
            <a:avLst/>
          </a:prstGeom>
          <a:ln w="0">
            <a:noFill/>
          </a:ln>
        </p:spPr>
      </p:pic>
      <p:sp>
        <p:nvSpPr>
          <p:cNvPr id="72" name="TextBox 8"/>
          <p:cNvSpPr/>
          <p:nvPr/>
        </p:nvSpPr>
        <p:spPr>
          <a:xfrm>
            <a:off x="0" y="0"/>
            <a:ext cx="550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BP (3Saline vs </a:t>
            </a:r>
            <a:r>
              <a:rPr b="0" lang="en-US" sz="18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3NMDA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TextBox 16"/>
          <p:cNvSpPr/>
          <p:nvPr/>
        </p:nvSpPr>
        <p:spPr>
          <a:xfrm>
            <a:off x="3492360" y="197964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BP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TextBox 17"/>
          <p:cNvSpPr/>
          <p:nvPr/>
        </p:nvSpPr>
        <p:spPr>
          <a:xfrm>
            <a:off x="3500280" y="277164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TextBox 8"/>
          <p:cNvSpPr/>
          <p:nvPr/>
        </p:nvSpPr>
        <p:spPr>
          <a:xfrm>
            <a:off x="0" y="701640"/>
            <a:ext cx="264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1set</a:t>
            </a:r>
            <a:r>
              <a:rPr b="0" lang="ko-KR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6" name="TextBox 5"/>
          <p:cNvSpPr/>
          <p:nvPr/>
        </p:nvSpPr>
        <p:spPr>
          <a:xfrm>
            <a:off x="277920" y="4173480"/>
            <a:ext cx="3214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1 M3 F3  F6  </a:t>
            </a: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2 M4 F2  F4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7" name="TextBox 16"/>
          <p:cNvSpPr/>
          <p:nvPr/>
        </p:nvSpPr>
        <p:spPr>
          <a:xfrm>
            <a:off x="3500280" y="479736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BP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8" name="TextBox 17"/>
          <p:cNvSpPr/>
          <p:nvPr/>
        </p:nvSpPr>
        <p:spPr>
          <a:xfrm>
            <a:off x="3635280" y="566100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TextBox 5"/>
          <p:cNvSpPr/>
          <p:nvPr/>
        </p:nvSpPr>
        <p:spPr>
          <a:xfrm>
            <a:off x="142920" y="3936960"/>
            <a:ext cx="32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44 #44 #44 #44  </a:t>
            </a:r>
            <a:r>
              <a:rPr b="1" lang="en-US" sz="14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#44 #44 #44 #4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TextBox 8"/>
          <p:cNvSpPr/>
          <p:nvPr/>
        </p:nvSpPr>
        <p:spPr>
          <a:xfrm>
            <a:off x="0" y="3571920"/>
            <a:ext cx="264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3set 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TextBox 16"/>
          <p:cNvSpPr/>
          <p:nvPr/>
        </p:nvSpPr>
        <p:spPr>
          <a:xfrm>
            <a:off x="8323200" y="173520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BP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TextBox 17"/>
          <p:cNvSpPr/>
          <p:nvPr/>
        </p:nvSpPr>
        <p:spPr>
          <a:xfrm>
            <a:off x="8323200" y="277164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TextBox 8"/>
          <p:cNvSpPr/>
          <p:nvPr/>
        </p:nvSpPr>
        <p:spPr>
          <a:xfrm>
            <a:off x="5003640" y="712800"/>
            <a:ext cx="2643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2set</a:t>
            </a:r>
            <a:r>
              <a:rPr b="0" lang="ko-KR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84" name="Picture 3" descr="C:\Documents and Settings\MYHOME\My Documents\WB\7차 WB추가(15%, 20140825- )\20140828Actin(15s).jpg"/>
          <p:cNvPicPr/>
          <p:nvPr/>
        </p:nvPicPr>
        <p:blipFill>
          <a:blip r:embed="rId2"/>
          <a:stretch/>
        </p:blipFill>
        <p:spPr>
          <a:xfrm>
            <a:off x="0" y="2486160"/>
            <a:ext cx="3600360" cy="79344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2" descr="C:\Documents and Settings\MYHOME\My Documents\WB\7차 WB추가(15%, 20140825- )\20140826MBP(30s).jpg"/>
          <p:cNvPicPr/>
          <p:nvPr/>
        </p:nvPicPr>
        <p:blipFill>
          <a:blip r:embed="rId3"/>
          <a:stretch/>
        </p:blipFill>
        <p:spPr>
          <a:xfrm>
            <a:off x="0" y="1557360"/>
            <a:ext cx="3600360" cy="1081080"/>
          </a:xfrm>
          <a:prstGeom prst="rect">
            <a:avLst/>
          </a:prstGeom>
          <a:ln w="0">
            <a:noFill/>
          </a:ln>
        </p:spPr>
      </p:pic>
      <p:sp>
        <p:nvSpPr>
          <p:cNvPr id="86" name="TextBox 5"/>
          <p:cNvSpPr/>
          <p:nvPr/>
        </p:nvSpPr>
        <p:spPr>
          <a:xfrm>
            <a:off x="122400" y="1082520"/>
            <a:ext cx="1857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#33#33#33#33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1 F2  F3  F5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TextBox 6"/>
          <p:cNvSpPr/>
          <p:nvPr/>
        </p:nvSpPr>
        <p:spPr>
          <a:xfrm>
            <a:off x="1692360" y="1082520"/>
            <a:ext cx="17859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33#33#32#3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 </a:t>
            </a: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3 F4  F1  F4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88" name="Picture 2" descr="C:\Documents and Settings\MYHOME\My Documents\WB\8차 WB정리 (20140715- )\20140715MBP(10s).jpg"/>
          <p:cNvPicPr/>
          <p:nvPr/>
        </p:nvPicPr>
        <p:blipFill>
          <a:blip r:embed="rId4"/>
          <a:stretch/>
        </p:blipFill>
        <p:spPr>
          <a:xfrm>
            <a:off x="5003640" y="1415880"/>
            <a:ext cx="3370320" cy="1308240"/>
          </a:xfrm>
          <a:prstGeom prst="rect">
            <a:avLst/>
          </a:prstGeom>
          <a:ln w="0">
            <a:noFill/>
          </a:ln>
        </p:spPr>
      </p:pic>
      <p:sp>
        <p:nvSpPr>
          <p:cNvPr id="89" name="TextBox 5"/>
          <p:cNvSpPr/>
          <p:nvPr/>
        </p:nvSpPr>
        <p:spPr>
          <a:xfrm>
            <a:off x="5091120" y="1082520"/>
            <a:ext cx="1857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32#42#42#4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 </a:t>
            </a: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1 M3 M6 F1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0" name="TextBox 6"/>
          <p:cNvSpPr/>
          <p:nvPr/>
        </p:nvSpPr>
        <p:spPr>
          <a:xfrm>
            <a:off x="6588000" y="1082520"/>
            <a:ext cx="17859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#32#42#42#4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3 M4 M5 M7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91" name="Picture 2" descr="C:\Documents and Settings\MYHOME\My Documents\WB\9차 WB정리 (20140903 - )\20140903MBP(1m).jpg"/>
          <p:cNvPicPr/>
          <p:nvPr/>
        </p:nvPicPr>
        <p:blipFill>
          <a:blip r:embed="rId5"/>
          <a:stretch/>
        </p:blipFill>
        <p:spPr>
          <a:xfrm>
            <a:off x="0" y="4437000"/>
            <a:ext cx="3600360" cy="108432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3" descr="C:\Documents and Settings\MYHOME\My Documents\WB\9차 WB정리 (20140903 - )\20140904Actin(20s).jpg"/>
          <p:cNvPicPr/>
          <p:nvPr/>
        </p:nvPicPr>
        <p:blipFill>
          <a:blip r:embed="rId6"/>
          <a:stretch/>
        </p:blipFill>
        <p:spPr>
          <a:xfrm>
            <a:off x="0" y="5362560"/>
            <a:ext cx="3708360" cy="1006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Picture 3" descr="C:\Documents and Settings\MYHOME\My Documents\WB\7차 WB정리 (20140522- )\20140522GFAP(20s-2).jpg"/>
          <p:cNvPicPr/>
          <p:nvPr/>
        </p:nvPicPr>
        <p:blipFill>
          <a:blip r:embed="rId1"/>
          <a:stretch/>
        </p:blipFill>
        <p:spPr>
          <a:xfrm>
            <a:off x="-93600" y="1413000"/>
            <a:ext cx="4022640" cy="74124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4" descr="C:\Documents and Settings\MYHOME\My Documents\WB\7차 WB정리 (20140522- )\20140526Actin(15s-2).jpg"/>
          <p:cNvPicPr/>
          <p:nvPr/>
        </p:nvPicPr>
        <p:blipFill>
          <a:blip r:embed="rId2"/>
          <a:stretch/>
        </p:blipFill>
        <p:spPr>
          <a:xfrm>
            <a:off x="-79200" y="2133720"/>
            <a:ext cx="4003560" cy="752400"/>
          </a:xfrm>
          <a:prstGeom prst="rect">
            <a:avLst/>
          </a:prstGeom>
          <a:ln w="0">
            <a:noFill/>
          </a:ln>
        </p:spPr>
      </p:pic>
      <p:pic>
        <p:nvPicPr>
          <p:cNvPr id="95" name="그림 42" descr="20140715GFAP(5s).jpg"/>
          <p:cNvPicPr/>
          <p:nvPr/>
        </p:nvPicPr>
        <p:blipFill>
          <a:blip r:embed="rId3"/>
          <a:stretch/>
        </p:blipFill>
        <p:spPr>
          <a:xfrm>
            <a:off x="5003640" y="1413000"/>
            <a:ext cx="3456000" cy="734760"/>
          </a:xfrm>
          <a:prstGeom prst="rect">
            <a:avLst/>
          </a:prstGeom>
          <a:ln w="0">
            <a:noFill/>
          </a:ln>
        </p:spPr>
      </p:pic>
      <p:sp>
        <p:nvSpPr>
          <p:cNvPr id="96" name="TextBox 8"/>
          <p:cNvSpPr/>
          <p:nvPr/>
        </p:nvSpPr>
        <p:spPr>
          <a:xfrm>
            <a:off x="0" y="0"/>
            <a:ext cx="550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GFAP (</a:t>
            </a:r>
            <a:r>
              <a:rPr b="0" lang="en-US" sz="18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3NMDA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vs 3Saline)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TextBox 16"/>
          <p:cNvSpPr/>
          <p:nvPr/>
        </p:nvSpPr>
        <p:spPr>
          <a:xfrm>
            <a:off x="3786120" y="155736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GFAP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TextBox 17"/>
          <p:cNvSpPr/>
          <p:nvPr/>
        </p:nvSpPr>
        <p:spPr>
          <a:xfrm>
            <a:off x="3859200" y="232416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TextBox 8"/>
          <p:cNvSpPr/>
          <p:nvPr/>
        </p:nvSpPr>
        <p:spPr>
          <a:xfrm>
            <a:off x="0" y="701640"/>
            <a:ext cx="264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1set</a:t>
            </a:r>
            <a:r>
              <a:rPr b="0" lang="ko-KR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0" name="TextBox 16"/>
          <p:cNvSpPr/>
          <p:nvPr/>
        </p:nvSpPr>
        <p:spPr>
          <a:xfrm>
            <a:off x="8323200" y="161928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GFAP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1" name="TextBox 8"/>
          <p:cNvSpPr/>
          <p:nvPr/>
        </p:nvSpPr>
        <p:spPr>
          <a:xfrm>
            <a:off x="5003640" y="712800"/>
            <a:ext cx="2643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2set</a:t>
            </a:r>
            <a:r>
              <a:rPr b="0" lang="ko-KR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35 cortex sample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2" name="TextBox 5"/>
          <p:cNvSpPr/>
          <p:nvPr/>
        </p:nvSpPr>
        <p:spPr>
          <a:xfrm>
            <a:off x="5091120" y="1082520"/>
            <a:ext cx="1857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32#42#42#4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 </a:t>
            </a: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1 M3 M6 F1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3" name="TextBox 6"/>
          <p:cNvSpPr/>
          <p:nvPr/>
        </p:nvSpPr>
        <p:spPr>
          <a:xfrm>
            <a:off x="6673680" y="1082520"/>
            <a:ext cx="17859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#32#42#42#4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3 M4 M5 M7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04" name="그림 41" descr="20140717Actin(10%,10s-2).jpg"/>
          <p:cNvPicPr/>
          <p:nvPr/>
        </p:nvPicPr>
        <p:blipFill>
          <a:blip r:embed="rId4"/>
          <a:stretch/>
        </p:blipFill>
        <p:spPr>
          <a:xfrm>
            <a:off x="5003640" y="2130480"/>
            <a:ext cx="3456000" cy="976320"/>
          </a:xfrm>
          <a:prstGeom prst="rect">
            <a:avLst/>
          </a:prstGeom>
          <a:ln w="0">
            <a:noFill/>
          </a:ln>
        </p:spPr>
      </p:pic>
      <p:sp>
        <p:nvSpPr>
          <p:cNvPr id="105" name="TextBox 17"/>
          <p:cNvSpPr/>
          <p:nvPr/>
        </p:nvSpPr>
        <p:spPr>
          <a:xfrm>
            <a:off x="8323200" y="241128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6" name="TextBox 5"/>
          <p:cNvSpPr/>
          <p:nvPr/>
        </p:nvSpPr>
        <p:spPr>
          <a:xfrm>
            <a:off x="423720" y="1082520"/>
            <a:ext cx="18576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#33#33#33#33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M1 F2  F3  F5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7" name="TextBox 6"/>
          <p:cNvSpPr/>
          <p:nvPr/>
        </p:nvSpPr>
        <p:spPr>
          <a:xfrm>
            <a:off x="1908000" y="1082520"/>
            <a:ext cx="17859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#33#33#32#3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 </a:t>
            </a:r>
            <a:r>
              <a:rPr b="1" lang="en-US" sz="1600" spc="-1" strike="noStrike">
                <a:solidFill>
                  <a:srgbClr val="c00000"/>
                </a:solidFill>
                <a:latin typeface="맑은 고딕"/>
                <a:ea typeface="맑은 고딕"/>
              </a:rPr>
              <a:t>M3 F4  F1  F4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20T03:40:31Z</dcterms:created>
  <dc:creator>해워니</dc:creator>
  <dc:description/>
  <dc:language>en-US</dc:language>
  <cp:lastModifiedBy>LMY_YMS</cp:lastModifiedBy>
  <dcterms:modified xsi:type="dcterms:W3CDTF">2018-03-12T05:45:22Z</dcterms:modified>
  <cp:revision>35</cp:revision>
  <dc:subject/>
  <dc:title>슬라이드 1</dc:title>
</cp:coreProperties>
</file>